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51FDF-3406-4556-93D4-D0766D1CEF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22731-B627-4D75-B359-42CD7B2C06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7DC44-D508-4C15-9948-D7F84301AE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01659F-F7FF-4D9A-9650-CE35D55EBB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62F86-8290-40DA-867B-DAA8480C7A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D5E91-E228-48EA-ABEF-459CA19761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7F6DE-9CB7-443F-B6A5-FBE78A42BB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1BF52-B364-4D91-AE08-597E80FD17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11F81A-8D92-420F-A931-B81B8ACD6D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84134-2B74-48A9-BE69-ACEE8C345A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9FEC8-BD88-4469-BB29-4CFBB161F7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39998-8F28-42C7-BB8E-5C0322A596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453D6F-27E6-4C68-B337-CCD09A6FF67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50920" y="765000"/>
            <a:ext cx="4537080" cy="29941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-4320" y="50760"/>
            <a:ext cx="235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upporting Information 2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9280" y="476280"/>
            <a:ext cx="3961080" cy="3384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81080" y="476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9280" y="4076640"/>
            <a:ext cx="835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upporting Information 2: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Expression of STAT1 (A) and Interferon-beta (B) in transfected cells. AsPC1 cells are depicted in white, MiaPaCa-2 cells are in grey. All samples were normalized to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-Actin as house keeping gen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2"/>
          <a:stretch/>
        </p:blipFill>
        <p:spPr>
          <a:xfrm>
            <a:off x="4643280" y="836640"/>
            <a:ext cx="4500720" cy="29257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4643280" y="476280"/>
            <a:ext cx="3816360" cy="3384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643280" y="476280"/>
            <a:ext cx="33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8T06:18:15Z</dcterms:created>
  <dc:creator>F. Rückert</dc:creator>
  <dc:description/>
  <dc:language>en-US</dc:language>
  <cp:lastModifiedBy>F. Rückert</cp:lastModifiedBy>
  <dcterms:modified xsi:type="dcterms:W3CDTF">2010-04-06T11:32:53Z</dcterms:modified>
  <cp:revision>11</cp:revision>
  <dc:subject/>
  <dc:title>Folie 1</dc:title>
</cp:coreProperties>
</file>